
<file path=[Content_Types].xml><?xml version="1.0" encoding="utf-8"?>
<Types xmlns="http://schemas.openxmlformats.org/package/2006/content-types">
  <Default Extension="jpeg" ContentType="image/jpeg"/>
  <Default Extension="jpg" ContentType="image/pn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5" r:id="rId5"/>
    <p:sldId id="263" r:id="rId6"/>
    <p:sldId id="258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64DC4C-0DA1-3E67-3457-4E6954DF067E}" v="6" dt="2023-06-05T08:37:18.772"/>
    <p1510:client id="{2C69B1D7-5903-2117-14F5-479024868196}" v="20" dt="2023-01-18T20:01:11.6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F611C-49E7-4A88-B1C8-6E6830DCEB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A1E896-12C7-4AD0-B479-C914C19F52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4963BE-D4EF-42C6-B053-90E32DCF0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C8554-CF0A-462F-9691-B47C759F1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82DE4F-C0A3-42B8-B7EE-950920FB0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392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C8218-B300-47CE-9600-026B35AE2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D733DC-73C9-44C4-85BA-DD27705A5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5FA0A-4EFC-4658-A2B2-C638DE570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061D0E-DCE1-4B3E-ACB3-E2C2E3879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EC2867-3201-4E4E-8B9F-C845B4691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788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21240D-0248-4E3D-A876-5EDC14C02A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B3892B-A003-4D58-A7F4-8581EDF29B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3BBD3-0A1A-4F48-9284-9B311C776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7121EA-8887-4A64-A5D0-47C6CBA85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0C487-CC45-4C15-B272-FA71AE205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2661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4A6AC-F105-4BE2-9B63-5B505E091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0D4C1-E1E9-4D78-B0BF-046023F95B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6FF1DB-27A8-41F1-AEEE-51177A8FB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E0D6F-522C-4FE8-81C4-813720F26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300FD-EA5A-479A-842C-D4A804F30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610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FC5BCF-85BB-42D5-8B59-E45500170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17BF9D-95A9-4B77-9A06-C92F7B7E26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66669B-BF23-4E98-B85E-28FE71D7B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08A81-2C35-4A33-850B-BD4B715E4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A02EA-3AEE-44EA-807B-C470B4C13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68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496F0-7DBE-4BDD-A90D-86B7B49A15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EDA0A-72AA-4DE3-9AFC-83C8EC29D5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F5993E-7B0A-49AE-AAFA-A11585B86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D9430B-0AA2-4431-B165-005C5F680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26BA93-38EC-4FF8-AC88-5ED478DA9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408D30-1660-4515-B06E-4A83F3F01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224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2710D-2CA6-4B25-B2EC-1D5D5FEA5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91C6CD-FFF1-4DC8-824B-2F14807F1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F77700-7438-4F2B-A497-7FE1A31C54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FAE84F-4F2E-4E34-955C-ADE6FF2CB2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07C7CB-101B-4040-9091-BF8EA85006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514DAE-6AEB-4C84-AC49-65A27735D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072236-0272-4952-891E-6EECDA7D6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17BD19-94CB-4BB8-88B3-7421A15CE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2711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69ADC-ECA7-4F38-96A7-CDC32A5B6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849D90-4D51-4632-90DB-988B9A8CF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D68920-A8A2-4DF1-9B64-553EA2777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E7207E-120F-47CE-9041-1590E591A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073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779E1D-68F2-4E7E-B563-F91FBE9BC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BA0F0C-41FC-4B85-9531-546D3750E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42ACE1-D9E8-438B-AE72-24ED950BB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5053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050404-DB2E-41A4-8B39-28D06671B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E197D-BC09-4C75-AD89-1F51700073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4295F-7C89-4967-BD65-143477FE2B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B92D21-9FAC-4224-9456-F0B01F652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B097AC-35F0-4D94-A67F-DAF8F399F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F63373-84ED-46D6-AA6E-DCBCD680D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42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5C208-C3C6-4634-AC58-76844300D1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DB919-D76F-46F6-90EF-9C7E021C02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03050A-BA01-41B7-8D24-2EB481B82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A3554D-CCAE-42D1-B2D6-B9B308E1A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684912-2B27-4B94-82A7-CF05307E2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8955E-4ED3-42DC-8E74-C64A94E72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563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CDE195-090C-4558-A448-FF038471E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081386-DA41-4913-A492-C473E6D77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5EC69E-E870-4DA4-9945-4E370158F4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89A1F-22C6-45F3-A1C0-A255AD4F3795}" type="datetimeFigureOut">
              <a:rPr lang="en-GB" smtClean="0"/>
              <a:t>05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CD819-04A4-423E-A89F-594691E538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ABCD7-790B-4FC8-8564-8A9428B44B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D7F08-5D2E-4AD7-8596-68A77C9BEE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60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EE92C4E-D533-4C02-89EE-2D0DD3562F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22453"/>
            <a:ext cx="6984646" cy="43288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B231A4E-5736-4E24-97B4-1091EC3FC2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8305" y="109993"/>
            <a:ext cx="3645531" cy="225937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FC7F1C2-ED8A-4A9C-8110-5232CD8052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8303" y="2323715"/>
            <a:ext cx="3645531" cy="225937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7810DF5-26B2-4677-93D3-84BAC5A3A4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8304" y="4598626"/>
            <a:ext cx="3645531" cy="225937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BC686B9-C267-46F3-B2A1-3923CAA15A87}"/>
              </a:ext>
            </a:extLst>
          </p:cNvPr>
          <p:cNvSpPr txBox="1"/>
          <p:nvPr/>
        </p:nvSpPr>
        <p:spPr>
          <a:xfrm>
            <a:off x="126262" y="51169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64E268-FE4D-4A51-8B9D-458B012F030B}"/>
              </a:ext>
            </a:extLst>
          </p:cNvPr>
          <p:cNvSpPr txBox="1"/>
          <p:nvPr/>
        </p:nvSpPr>
        <p:spPr>
          <a:xfrm>
            <a:off x="7722583" y="17619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8F9D9A7-F064-4D4E-8468-6791CCFEA619}"/>
              </a:ext>
            </a:extLst>
          </p:cNvPr>
          <p:cNvSpPr txBox="1"/>
          <p:nvPr/>
        </p:nvSpPr>
        <p:spPr>
          <a:xfrm>
            <a:off x="7722583" y="39756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7A5D23D-B07F-49F3-B18C-4AC7FD226909}"/>
              </a:ext>
            </a:extLst>
          </p:cNvPr>
          <p:cNvSpPr txBox="1"/>
          <p:nvPr/>
        </p:nvSpPr>
        <p:spPr>
          <a:xfrm>
            <a:off x="7722583" y="61831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CEA4BD1-206D-45BB-8741-EBCC7861F45A}"/>
              </a:ext>
            </a:extLst>
          </p:cNvPr>
          <p:cNvGrpSpPr/>
          <p:nvPr/>
        </p:nvGrpSpPr>
        <p:grpSpPr>
          <a:xfrm>
            <a:off x="1023337" y="5751429"/>
            <a:ext cx="5072663" cy="668403"/>
            <a:chOff x="6392897" y="5337101"/>
            <a:chExt cx="5072663" cy="66840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BD871AB-1B97-4935-A3F3-44BF12C46C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861" r="33343" b="45890"/>
            <a:stretch/>
          </p:blipFill>
          <p:spPr>
            <a:xfrm>
              <a:off x="6392897" y="5337101"/>
              <a:ext cx="5072663" cy="397874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530C48B-D240-42CE-B124-E841D8CAE0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5" t="49181" r="24976" b="45890"/>
            <a:stretch/>
          </p:blipFill>
          <p:spPr>
            <a:xfrm>
              <a:off x="6586855" y="5734975"/>
              <a:ext cx="621665" cy="270529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0FFA5B4-CB5D-4D4B-85F8-2BEE4D7745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81" t="49181" r="1" b="45890"/>
            <a:stretch/>
          </p:blipFill>
          <p:spPr>
            <a:xfrm>
              <a:off x="7730490" y="5734974"/>
              <a:ext cx="1919158" cy="270529"/>
            </a:xfrm>
            <a:prstGeom prst="rect">
              <a:avLst/>
            </a:prstGeom>
          </p:spPr>
        </p:pic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70553324-9207-4763-B5D8-A941994785BE}"/>
              </a:ext>
            </a:extLst>
          </p:cNvPr>
          <p:cNvSpPr txBox="1"/>
          <p:nvPr/>
        </p:nvSpPr>
        <p:spPr>
          <a:xfrm>
            <a:off x="126262" y="177121"/>
            <a:ext cx="7220659" cy="7078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000" b="1" dirty="0">
                <a:latin typeface="Arial"/>
                <a:cs typeface="Arial"/>
              </a:rPr>
              <a:t>Figure S2</a:t>
            </a:r>
            <a:r>
              <a:rPr lang="en-GB" sz="2000" dirty="0">
                <a:latin typeface="Arial"/>
                <a:cs typeface="Arial"/>
              </a:rPr>
              <a:t> DAH in polio priority-transition countries in the past 18 years by type of dono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E8D31E2-8133-42E7-9D9A-38AD5E1E9A8B}"/>
              </a:ext>
            </a:extLst>
          </p:cNvPr>
          <p:cNvSpPr txBox="1"/>
          <p:nvPr/>
        </p:nvSpPr>
        <p:spPr>
          <a:xfrm>
            <a:off x="126262" y="814182"/>
            <a:ext cx="77329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All polio transition priority countries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 and those based on their WHO regions: AF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, EM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, and SEAR (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3139569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BB22E27-9527-4CEA-80E7-04463D0BED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84" y="0"/>
            <a:ext cx="9508992" cy="6858000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B900AE60-3E9B-4275-9F45-50E8EE8BB639}"/>
              </a:ext>
            </a:extLst>
          </p:cNvPr>
          <p:cNvGrpSpPr/>
          <p:nvPr/>
        </p:nvGrpSpPr>
        <p:grpSpPr>
          <a:xfrm>
            <a:off x="6555457" y="6048301"/>
            <a:ext cx="5072663" cy="668403"/>
            <a:chOff x="6392897" y="5337101"/>
            <a:chExt cx="5072663" cy="668403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984DF87-6AEC-4A18-A5F5-9C30776674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861" r="33343" b="45890"/>
            <a:stretch/>
          </p:blipFill>
          <p:spPr>
            <a:xfrm>
              <a:off x="6392897" y="5337101"/>
              <a:ext cx="5072663" cy="39787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13E0E5F-C373-4CD5-9EB3-079669A9E7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5" t="49181" r="24976" b="45890"/>
            <a:stretch/>
          </p:blipFill>
          <p:spPr>
            <a:xfrm>
              <a:off x="6586855" y="5734975"/>
              <a:ext cx="621665" cy="270529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314CE2E-9D63-43BE-B9E6-A0B8DED4F8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81" t="49181" r="1" b="45890"/>
            <a:stretch/>
          </p:blipFill>
          <p:spPr>
            <a:xfrm>
              <a:off x="7730490" y="5734974"/>
              <a:ext cx="1919158" cy="2705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98116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34787F8-A90A-4750-9950-83354CE434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263" y="0"/>
            <a:ext cx="9508992" cy="6858000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A2FF5DBD-BB13-4956-9FAF-D26A0CACFB8A}"/>
              </a:ext>
            </a:extLst>
          </p:cNvPr>
          <p:cNvGrpSpPr/>
          <p:nvPr/>
        </p:nvGrpSpPr>
        <p:grpSpPr>
          <a:xfrm>
            <a:off x="6555457" y="6048301"/>
            <a:ext cx="5072663" cy="668403"/>
            <a:chOff x="6392897" y="5337101"/>
            <a:chExt cx="5072663" cy="66840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784795A-7716-4E21-A505-FF4B9CCB24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861" r="33343" b="45890"/>
            <a:stretch/>
          </p:blipFill>
          <p:spPr>
            <a:xfrm>
              <a:off x="6392897" y="5337101"/>
              <a:ext cx="5072663" cy="39787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C6BBF81-A0D7-4DA8-BCCE-6CDE79D469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5" t="49181" r="24976" b="45890"/>
            <a:stretch/>
          </p:blipFill>
          <p:spPr>
            <a:xfrm>
              <a:off x="6586855" y="5734975"/>
              <a:ext cx="621665" cy="270529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3D898EF-B35C-4337-814E-20360F84FB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81" t="49181" r="1" b="45890"/>
            <a:stretch/>
          </p:blipFill>
          <p:spPr>
            <a:xfrm>
              <a:off x="7730490" y="5734974"/>
              <a:ext cx="1919158" cy="2705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2392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E05A138-8D50-4095-B896-F6E46964A6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84" y="0"/>
            <a:ext cx="9508992" cy="68580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5F86A8FD-A417-4113-A27F-336AB358D515}"/>
              </a:ext>
            </a:extLst>
          </p:cNvPr>
          <p:cNvGrpSpPr/>
          <p:nvPr/>
        </p:nvGrpSpPr>
        <p:grpSpPr>
          <a:xfrm>
            <a:off x="6555457" y="6048301"/>
            <a:ext cx="5072663" cy="668403"/>
            <a:chOff x="6392897" y="5337101"/>
            <a:chExt cx="5072663" cy="66840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A6BF746-3764-48A0-9194-551CD12ECD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861" r="33343" b="45890"/>
            <a:stretch/>
          </p:blipFill>
          <p:spPr>
            <a:xfrm>
              <a:off x="6392897" y="5337101"/>
              <a:ext cx="5072663" cy="39787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ECEC953-3FC8-44EF-9204-5B1D699F95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5" t="49181" r="24976" b="45890"/>
            <a:stretch/>
          </p:blipFill>
          <p:spPr>
            <a:xfrm>
              <a:off x="6586855" y="5734975"/>
              <a:ext cx="621665" cy="270529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0ECA990-FEB7-4FB1-81AA-67A1E2AFDD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81" t="49181" r="1" b="45890"/>
            <a:stretch/>
          </p:blipFill>
          <p:spPr>
            <a:xfrm>
              <a:off x="7730490" y="5734974"/>
              <a:ext cx="1919158" cy="2705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8502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0B671BC794A474F93336529414137EE" ma:contentTypeVersion="16" ma:contentTypeDescription="Create a new document." ma:contentTypeScope="" ma:versionID="71e031bb660092f856ab3602626b9977">
  <xsd:schema xmlns:xsd="http://www.w3.org/2001/XMLSchema" xmlns:xs="http://www.w3.org/2001/XMLSchema" xmlns:p="http://schemas.microsoft.com/office/2006/metadata/properties" xmlns:ns2="76b97e0f-0b6c-4862-a8b7-8ef0847a5b25" xmlns:ns3="31bac29d-635b-4ff2-84e9-4347505f3004" targetNamespace="http://schemas.microsoft.com/office/2006/metadata/properties" ma:root="true" ma:fieldsID="5e414e3bd099346c9a13df90e673e448" ns2:_="" ns3:_="">
    <xsd:import namespace="76b97e0f-0b6c-4862-a8b7-8ef0847a5b25"/>
    <xsd:import namespace="31bac29d-635b-4ff2-84e9-4347505f300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6b97e0f-0b6c-4862-a8b7-8ef0847a5b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aa4eac88-8ae6-4a96-90c7-97bc93c844e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bac29d-635b-4ff2-84e9-4347505f3004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cad81af6-b875-4386-8c2f-e831e19173c4}" ma:internalName="TaxCatchAll" ma:showField="CatchAllData" ma:web="31bac29d-635b-4ff2-84e9-4347505f300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1bac29d-635b-4ff2-84e9-4347505f3004" xsi:nil="true"/>
    <lcf76f155ced4ddcb4097134ff3c332f xmlns="76b97e0f-0b6c-4862-a8b7-8ef0847a5b2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3D3FCBD9-FD8C-4309-B677-4A35AF709AD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FDAC3B-C29B-4094-90C7-6888CB7EED1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6b97e0f-0b6c-4862-a8b7-8ef0847a5b25"/>
    <ds:schemaRef ds:uri="31bac29d-635b-4ff2-84e9-4347505f30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D996186-1CFD-4E97-A849-EA3B18BA3E3E}">
  <ds:schemaRefs>
    <ds:schemaRef ds:uri="4dd27b94-49dd-407e-a06f-ee9bee375f57"/>
    <ds:schemaRef ds:uri="http://purl.org/dc/dcmitype/"/>
    <ds:schemaRef ds:uri="http://purl.org/dc/terms/"/>
    <ds:schemaRef ds:uri="http://schemas.openxmlformats.org/package/2006/metadata/core-properties"/>
    <ds:schemaRef ds:uri="http://www.w3.org/XML/1998/namespace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68436cf0-bded-48b0-966e-c872f964e37c"/>
    <ds:schemaRef ds:uri="http://schemas.microsoft.com/office/2006/metadata/properties"/>
    <ds:schemaRef ds:uri="31bac29d-635b-4ff2-84e9-4347505f3004"/>
    <ds:schemaRef ds:uri="76b97e0f-0b6c-4862-a8b7-8ef0847a5b2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Villa</dc:creator>
  <cp:lastModifiedBy>POLITI, Claudio</cp:lastModifiedBy>
  <cp:revision>21</cp:revision>
  <dcterms:created xsi:type="dcterms:W3CDTF">2022-12-27T20:42:42Z</dcterms:created>
  <dcterms:modified xsi:type="dcterms:W3CDTF">2023-06-05T08:38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B671BC794A474F93336529414137EE</vt:lpwstr>
  </property>
  <property fmtid="{D5CDD505-2E9C-101B-9397-08002B2CF9AE}" pid="3" name="MediaServiceImageTags">
    <vt:lpwstr/>
  </property>
</Properties>
</file>